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2" r:id="rId5"/>
    <p:sldId id="263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4424" autoAdjust="0"/>
  </p:normalViewPr>
  <p:slideViewPr>
    <p:cSldViewPr snapToGrid="0">
      <p:cViewPr>
        <p:scale>
          <a:sx n="66" d="100"/>
          <a:sy n="66" d="100"/>
        </p:scale>
        <p:origin x="1314" y="252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ADB76D-8312-4EE0-A007-9A2C3F73B95B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A5E466-FA1F-4735-A346-A675CB5E04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64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A5E466-FA1F-4735-A346-A675CB5E04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519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963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697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679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88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144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433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942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511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056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9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075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9C4EC-CE43-4BEF-938E-A18F6AE8B58C}" type="datetimeFigureOut">
              <a:rPr lang="en-US" smtClean="0"/>
              <a:t>11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3CFAB-7CCA-44AA-B8C6-E9FDC04335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131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62475"/>
            <a:ext cx="10515600" cy="1500187"/>
          </a:xfrm>
        </p:spPr>
        <p:txBody>
          <a:bodyPr>
            <a:normAutofit/>
          </a:bodyPr>
          <a:lstStyle/>
          <a:p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. Comparison of volume of new epidermis of studied groups by least significant test. ARG. , Arginine, INJ., injection.</a:t>
            </a:r>
            <a:endParaRPr lang="en-US" sz="1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8424" y="95535"/>
            <a:ext cx="7936932" cy="4464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659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662033"/>
            <a:ext cx="10515600" cy="1500187"/>
          </a:xfrm>
        </p:spPr>
        <p:txBody>
          <a:bodyPr/>
          <a:lstStyle/>
          <a:p>
            <a:r>
              <a:rPr lang="en-US" sz="1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. Comparison of volume of new dermis of studied groups by least significant </a:t>
            </a:r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st.  </a:t>
            </a:r>
            <a:r>
              <a:rPr lang="en-US" sz="1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p &lt; 0.05; **p &lt; 0.01; ***p &lt; 0.001. ARG. , Arginine, INJ., injection.</a:t>
            </a:r>
          </a:p>
          <a:p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6913" y="406873"/>
            <a:ext cx="7588156" cy="4268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5144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662033"/>
            <a:ext cx="10515600" cy="1500187"/>
          </a:xfrm>
        </p:spPr>
        <p:txBody>
          <a:bodyPr/>
          <a:lstStyle/>
          <a:p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3. Comparison of fibroblast number of studied groups by least significant test. ***p &lt; 0.001. ARG. , Arginine, INJ., injection.</a:t>
            </a:r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3955" y="437882"/>
            <a:ext cx="7572777" cy="4259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4265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4. Comparison of neutrophil number of studied groups by least significant test. ARG. , Arginine, INJ., injection.</a:t>
            </a:r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0"/>
            <a:ext cx="8229599" cy="4629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45399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647519"/>
            <a:ext cx="10515600" cy="1500187"/>
          </a:xfrm>
        </p:spPr>
        <p:txBody>
          <a:bodyPr/>
          <a:lstStyle/>
          <a:p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5. Comparison of basal cell number of new epidermis of studied groups by least significant test.. ARG. , Arginine, INJ., injection.</a:t>
            </a:r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2890" y="0"/>
            <a:ext cx="8345510" cy="46943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02366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6. Comparison of angiogenesis of studied groups by least significant test.. ARG. , Arginine, INJ., injection.</a:t>
            </a:r>
          </a:p>
          <a:p>
            <a:endParaRPr lang="en-US" dirty="0" smtClean="0"/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7332" y="0"/>
            <a:ext cx="8111067" cy="4562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6384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72</Words>
  <Application>Microsoft Office PowerPoint</Application>
  <PresentationFormat>Widescreen</PresentationFormat>
  <Paragraphs>7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atenator@gmail.com</dc:creator>
  <cp:lastModifiedBy>Alojera, Michelle</cp:lastModifiedBy>
  <cp:revision>11</cp:revision>
  <dcterms:created xsi:type="dcterms:W3CDTF">2019-09-04T20:42:50Z</dcterms:created>
  <dcterms:modified xsi:type="dcterms:W3CDTF">2019-11-22T17:13:26Z</dcterms:modified>
</cp:coreProperties>
</file>